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53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8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B1FB10-D472-764B-87F9-C134BDEA3E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5379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F8335CA-D7DB-ABA9-8E09-33BE158582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9575" y="14111"/>
            <a:ext cx="6038850" cy="773079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18B3A32-D661-0350-4D8C-4F177A005F8B}"/>
              </a:ext>
            </a:extLst>
          </p:cNvPr>
          <p:cNvSpPr txBox="1"/>
          <p:nvPr/>
        </p:nvSpPr>
        <p:spPr>
          <a:xfrm>
            <a:off x="0" y="7744902"/>
            <a:ext cx="6858000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000" b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ffect of C458 treatment on the activity of complexes II-V, cellular respiration and ATP production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a-c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458 does not inhibit enzymatic activity of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ccinate:cytochrome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 reductase (complexes II-III),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errocytochrome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 oxidase (complex IV only), and ATP synthase (complex V). 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2 and C458 decrease ATP levels in primary mouse cortical neurons after 24 hours of treatment.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racellular acidification rate (ECAR) was measured for 120 min in MC65 cells Tet-On cells following the injection of different doses of C458 or rotenone. 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Quantification of OCR data presented in Fig. 2f. 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ability of MC65 Tet-On cells treated with 25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1 mM of rotenone for 72 hours.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CR was measured for 120 min in MC65 Tet-On cells following the injection of different doses of rotenone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are mean ± SD. * </a:t>
            </a:r>
            <a:r>
              <a:rPr lang="en-US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&lt; 0.05; **</a:t>
            </a:r>
            <a:r>
              <a:rPr lang="en-US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 0.01; ***</a:t>
            </a:r>
            <a:r>
              <a:rPr lang="en-US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 0.001, ****</a:t>
            </a:r>
            <a:r>
              <a:rPr lang="en-US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0.0001. </a:t>
            </a:r>
            <a:endParaRPr lang="en-US" sz="10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0091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7</TotalTime>
  <Words>176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23:35Z</dcterms:modified>
</cp:coreProperties>
</file>